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0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1F6F94-2FBF-47A3-84AF-78DA4657C9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C1B8F00-852A-473E-A4E0-9616BE6538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1F9BCB-8E70-43E7-AF6E-F6411BE72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22DADC-8C0F-4090-B32E-ACE0B4F36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0738E3-71A6-46A0-A863-E8C7AC86D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24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82F681-2EC3-44D3-A7F2-B1EED530D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B413095-6B14-4D5A-8E15-A71379E06B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2414F7-A51A-46D7-B8F5-995E4502F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490CA0-92ED-4948-823D-DCE934D15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CE03BD-57C9-4159-A217-9EEC604AA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350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FFB124D-B72B-4631-AC19-E4EB68061E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1A3BCBE-CFE6-478A-87D6-55C7748081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A2B0FF-4D27-4AC9-A42C-7857ED3D3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A0CE8F-7561-4F94-A42D-96E128D8D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7A0BC8-C953-4209-BE43-D9316EB36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1679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4C09AF-2573-4904-ABAB-1959D9D57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C32554-22F1-4FCA-AC90-B968165536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AA6D46-6EE2-4B6A-9A48-8B323572C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8C80FA-C0C6-4B97-B422-CCB6072D0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D28A2D-5E32-431E-9BA5-2E99374DE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5344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273B0C-4CF3-4768-8219-7FE849911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2784B4-DDAD-470F-AF97-16737EB93D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67C62D-395A-4788-B861-6651F5929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26A4F0-7BEB-4D0D-AD59-39D9F0AB1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5FFE92-A84D-4A8D-BC38-58A7D243E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543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96C965-50C4-4F9B-AAB6-05B487C8E0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9F5318-C7DD-4FA9-8813-5B7F38F42B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A78D99-5D0C-4D30-A5E2-F8782B4FC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F6AEF2-19D0-4A9A-91C7-74C5D4C72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222FCB0-E12C-450D-BB1A-81696F735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F520D1-492C-4142-A570-1C266146E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4688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43329-CFC2-408C-90A3-0D70971F8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EE9B70-8B8B-483D-B3CB-682D27079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E581CD8-D7F7-4EE4-AD7D-CCB0B9994E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64592BC-14ED-4D18-AB5F-29B9C8650F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6E8999A-96D9-4E23-9A6D-D5D0C94729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9084311-A80C-4487-A295-590F484CD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2F39DC2-45DA-4EC6-A65E-0D83A9DC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A18DD4C-A034-42FF-9C23-589A6F3A7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910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E52CF1-5CFE-4919-890B-A82A0944D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934EDAF-8057-440F-B9F0-022EA4686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353BF64-6AAB-4D81-8612-1DE4E0060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ABE01F8-67EF-4C91-8B91-271B1C155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3541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34B171-C291-49FF-AA2D-56E21B004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C7AEE30-4943-49C7-8287-E76B552EC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0B1E661-B44F-4E7C-B73B-53470088D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5195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26B6E2-9B42-4329-B4B9-6B56BA8E5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2F0244-7933-4098-B2ED-4566E03B99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B79F011-93D9-4832-B37B-CA87B6760B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4655D14-A42E-49D2-8B88-BD0329030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29BF13-B92C-401C-8325-91D62BFED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43FFDB-A9D7-4C46-A6BF-BFE7C0374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3277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A7B726-D424-41ED-890F-3675F7CAFA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8E42950-B577-44EB-B96F-92770C68DB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03403AD-E96A-4898-886D-77FDCA16E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44F79D-ACB0-449C-AF4B-64BC27C45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E2F527-C762-4C30-B6E3-CD1E9FA0C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12F4B7-55C2-4BD6-9E35-DECCDE7F5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7227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85A5C1D-6A3E-43ED-A217-D88C7E9F4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4DBEBF0-20B3-4748-B595-C400C5392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027774-B5AB-4751-ACA0-8F570EEBFC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0EA2E-0D46-4E4D-81C5-DB0E1A47CF38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0B9ABB-D0B6-4709-AD7A-961701BB61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BD19D9-AB16-4A60-8E93-991892566F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72185-1587-4C17-AE33-1F1C89668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1AEE5F-C6A6-8104-B735-618C6E4CB4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8808B18-102E-5055-E44E-D9BCEA1048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04" t="33972" r="3249" b="4566"/>
          <a:stretch>
            <a:fillRect/>
          </a:stretch>
        </p:blipFill>
        <p:spPr>
          <a:xfrm>
            <a:off x="3169086" y="670141"/>
            <a:ext cx="4828783" cy="421500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4AA881F-1497-AAD9-189C-6FE11BE700C2}"/>
              </a:ext>
            </a:extLst>
          </p:cNvPr>
          <p:cNvSpPr txBox="1"/>
          <p:nvPr/>
        </p:nvSpPr>
        <p:spPr>
          <a:xfrm>
            <a:off x="2098110" y="5123238"/>
            <a:ext cx="83072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Distribution Proportions of DCE-MRI Radiomic Featur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5769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3F8806-2ED6-3424-6BE7-495290D2EE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90C3D813-0876-2CDE-9A44-C0842B1E6D98}"/>
              </a:ext>
            </a:extLst>
          </p:cNvPr>
          <p:cNvSpPr txBox="1"/>
          <p:nvPr/>
        </p:nvSpPr>
        <p:spPr>
          <a:xfrm>
            <a:off x="1326192" y="5671367"/>
            <a:ext cx="895141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 The process of radiomic features selection in the training set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LASSO method. (A, B) and (C, D) are for OR-DCE and SR-DCE model, respectively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02CB58D6-E537-2AFE-369B-801C4C18EFF9}"/>
              </a:ext>
            </a:extLst>
          </p:cNvPr>
          <p:cNvGrpSpPr/>
          <p:nvPr/>
        </p:nvGrpSpPr>
        <p:grpSpPr>
          <a:xfrm>
            <a:off x="2021584" y="0"/>
            <a:ext cx="7072771" cy="5652577"/>
            <a:chOff x="1940165" y="18790"/>
            <a:chExt cx="7072771" cy="5652577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F849B4EA-EEFA-4B0D-EBC3-68913C3728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88489" y="68894"/>
              <a:ext cx="3433178" cy="2719348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725C6E7-6836-AF77-544A-D3A22F3F4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0165" y="68894"/>
              <a:ext cx="3436010" cy="2719348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696D152-6FC3-F15B-2B3F-CFAC57AEBA9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2039" y="2952019"/>
              <a:ext cx="3506078" cy="2719348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01B40242-B6ED-E194-4DEC-4F6B2BF7C37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0165" y="2901915"/>
              <a:ext cx="3463322" cy="2719348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4086F861-EE4B-AB1A-CC30-FB1EE0ED1A32}"/>
                </a:ext>
              </a:extLst>
            </p:cNvPr>
            <p:cNvSpPr txBox="1"/>
            <p:nvPr/>
          </p:nvSpPr>
          <p:spPr>
            <a:xfrm>
              <a:off x="4925236" y="18790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D58D5E55-187E-BA99-A3EB-F387E3B417CE}"/>
                </a:ext>
              </a:extLst>
            </p:cNvPr>
            <p:cNvSpPr txBox="1"/>
            <p:nvPr/>
          </p:nvSpPr>
          <p:spPr>
            <a:xfrm>
              <a:off x="5001102" y="2901915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4E4199A-2C36-DE55-808E-9C95871803CF}"/>
                </a:ext>
              </a:extLst>
            </p:cNvPr>
            <p:cNvSpPr txBox="1"/>
            <p:nvPr/>
          </p:nvSpPr>
          <p:spPr>
            <a:xfrm>
              <a:off x="8561999" y="18790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5A13776-E9A5-E1F7-6257-C7411451F0F7}"/>
                </a:ext>
              </a:extLst>
            </p:cNvPr>
            <p:cNvSpPr txBox="1"/>
            <p:nvPr/>
          </p:nvSpPr>
          <p:spPr>
            <a:xfrm>
              <a:off x="8555732" y="2901915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8948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08AF40-5EED-B1DB-27FA-AD6D670EFE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62DF6BEB-EC78-70F6-82CC-112B28677C5C}"/>
              </a:ext>
            </a:extLst>
          </p:cNvPr>
          <p:cNvSpPr txBox="1"/>
          <p:nvPr/>
        </p:nvSpPr>
        <p:spPr>
          <a:xfrm>
            <a:off x="3814174" y="6029140"/>
            <a:ext cx="616343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 Coefficient of selected features from OR-DCE (a) and SR-DCE (b), respectively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A5F6BD1F-4FC8-5238-0C41-C0EF0E30FE06}"/>
              </a:ext>
            </a:extLst>
          </p:cNvPr>
          <p:cNvGrpSpPr/>
          <p:nvPr/>
        </p:nvGrpSpPr>
        <p:grpSpPr>
          <a:xfrm>
            <a:off x="3750612" y="22035"/>
            <a:ext cx="5905232" cy="6007105"/>
            <a:chOff x="3700508" y="0"/>
            <a:chExt cx="5905232" cy="6007105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78BB91B8-C265-AB35-735F-42352B0CA1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0508" y="0"/>
              <a:ext cx="5836292" cy="3022018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39DFC29A-C4FE-E1C9-E9FE-19A35633A5A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8684" y="3044052"/>
              <a:ext cx="5897056" cy="2963053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531E7C38-0019-16CB-35C8-C50833601EB7}"/>
                </a:ext>
              </a:extLst>
            </p:cNvPr>
            <p:cNvSpPr txBox="1"/>
            <p:nvPr/>
          </p:nvSpPr>
          <p:spPr>
            <a:xfrm>
              <a:off x="5805639" y="182529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DE084197-3F76-7744-758C-0635B0EB4EF0}"/>
                </a:ext>
              </a:extLst>
            </p:cNvPr>
            <p:cNvSpPr txBox="1"/>
            <p:nvPr/>
          </p:nvSpPr>
          <p:spPr>
            <a:xfrm>
              <a:off x="5870531" y="3143934"/>
              <a:ext cx="4509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4812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75</TotalTime>
  <Words>74</Words>
  <Application>Microsoft Office PowerPoint</Application>
  <PresentationFormat>宽屏</PresentationFormat>
  <Paragraphs>1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婷婷 崔</cp:lastModifiedBy>
  <cp:revision>76</cp:revision>
  <dcterms:created xsi:type="dcterms:W3CDTF">2021-05-15T11:42:33Z</dcterms:created>
  <dcterms:modified xsi:type="dcterms:W3CDTF">2025-10-08T15:21:12Z</dcterms:modified>
</cp:coreProperties>
</file>